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5" autoAdjust="0"/>
    <p:restoredTop sz="94660"/>
  </p:normalViewPr>
  <p:slideViewPr>
    <p:cSldViewPr>
      <p:cViewPr varScale="1">
        <p:scale>
          <a:sx n="52" d="100"/>
          <a:sy n="52" d="100"/>
        </p:scale>
        <p:origin x="2573" y="5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A2C49A-7464-4DE8-965D-E62741F2F2F6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D5CC05-63A6-42B9-AFFB-E41D99943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826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39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359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978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871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351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57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096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463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420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798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814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C5B57F-021F-4839-9E95-A950C13457E1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C3BEFA-8452-4B96-BCAE-595A6CBDC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087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jpeg"/><Relationship Id="rId19" Type="http://schemas.microsoft.com/office/2007/relationships/hdphoto" Target="../media/hdphoto9.wdp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CF1CEA9E-DB14-EFB8-174B-12ACDDA2666E}"/>
              </a:ext>
            </a:extLst>
          </p:cNvPr>
          <p:cNvGrpSpPr/>
          <p:nvPr/>
        </p:nvGrpSpPr>
        <p:grpSpPr>
          <a:xfrm>
            <a:off x="392807" y="202837"/>
            <a:ext cx="6121974" cy="6790573"/>
            <a:chOff x="392807" y="202837"/>
            <a:chExt cx="6121974" cy="6790573"/>
          </a:xfrm>
        </p:grpSpPr>
        <p:grpSp>
          <p:nvGrpSpPr>
            <p:cNvPr id="2" name="Group 1"/>
            <p:cNvGrpSpPr/>
            <p:nvPr/>
          </p:nvGrpSpPr>
          <p:grpSpPr>
            <a:xfrm>
              <a:off x="392807" y="202837"/>
              <a:ext cx="6056976" cy="4353206"/>
              <a:chOff x="625342" y="317306"/>
              <a:chExt cx="8075968" cy="5804274"/>
            </a:xfrm>
          </p:grpSpPr>
          <p:pic>
            <p:nvPicPr>
              <p:cNvPr id="1027" name="Picture 3" descr="D:\Projects &amp; Application\UVS 50 lakhs project, 2020-2021\Eggs and Oocyst photos\Oesophago\IMG00279, Oeso.JPG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212" r="32474" b="8195"/>
              <a:stretch/>
            </p:blipFill>
            <p:spPr bwMode="auto">
              <a:xfrm rot="16200000">
                <a:off x="3616307" y="442413"/>
                <a:ext cx="2578286" cy="232808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8" name="Picture 4" descr="D:\Projects &amp; Application\UVS 50 lakhs project, 2020-2021\Eggs and Oocyst photos\Ascaris\Ascaris 1, IMG00386.JPG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079" t="20875" r="37317" b="7869"/>
              <a:stretch/>
            </p:blipFill>
            <p:spPr bwMode="auto">
              <a:xfrm rot="16200000">
                <a:off x="580848" y="361800"/>
                <a:ext cx="2578289" cy="2489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0" name="Picture 6" descr="D:\Projects &amp; Application\UVS 50 lakhs project, 2020-2021\Eggs and Oocyst photos\Strongyloides\IMG00415, Strongyloides.JPG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214" t="17360" r="17786"/>
              <a:stretch/>
            </p:blipFill>
            <p:spPr bwMode="auto">
              <a:xfrm rot="16200000">
                <a:off x="6300012" y="494302"/>
                <a:ext cx="2578286" cy="222431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1" name="Picture 7" descr="D:\Projects &amp; Application\UVS 50 lakhs project, 2020-2021\Eggs and Oocyst photos\Trichuris\IMG00439, Trichuris.JPG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34" t="16586" r="32977" b="24916"/>
              <a:stretch/>
            </p:blipFill>
            <p:spPr bwMode="auto">
              <a:xfrm>
                <a:off x="647687" y="3728899"/>
                <a:ext cx="2132367" cy="239268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2" name="Picture 8" descr="D:\Projects &amp; Application\UVS 50 lakhs project, 2020-2021\Eggs and Oocyst photos\Metastrongylus\Meta 2, IMG00400.JPG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189" t="26896" r="26826" b="15172"/>
              <a:stretch/>
            </p:blipFill>
            <p:spPr bwMode="auto">
              <a:xfrm>
                <a:off x="3583036" y="3940256"/>
                <a:ext cx="2560319" cy="170687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3FAE3D96-E644-0181-B1CB-2E57C7052FA5}"/>
                </a:ext>
              </a:extLst>
            </p:cNvPr>
            <p:cNvGrpSpPr/>
            <p:nvPr/>
          </p:nvGrpSpPr>
          <p:grpSpPr>
            <a:xfrm>
              <a:off x="1600200" y="1753280"/>
              <a:ext cx="627863" cy="294735"/>
              <a:chOff x="2137949" y="2350220"/>
              <a:chExt cx="837150" cy="392980"/>
            </a:xfrm>
          </p:grpSpPr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7FA2E5DF-577B-D540-1056-9AA615979E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37949" y="2743200"/>
                <a:ext cx="83715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F47F83E-3F04-29F9-8C43-A11EC3699A3B}"/>
                  </a:ext>
                </a:extLst>
              </p:cNvPr>
              <p:cNvSpPr txBox="1"/>
              <p:nvPr/>
            </p:nvSpPr>
            <p:spPr>
              <a:xfrm>
                <a:off x="2239551" y="2350220"/>
                <a:ext cx="7296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40</a:t>
                </a:r>
                <a:r>
                  <a:rPr lang="en-US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m</a:t>
                </a:r>
                <a:endParaRPr lang="en-US" sz="1200" dirty="0"/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D412201A-5E5E-42EB-3E49-ECAA3E72F427}"/>
                </a:ext>
              </a:extLst>
            </p:cNvPr>
            <p:cNvGrpSpPr/>
            <p:nvPr/>
          </p:nvGrpSpPr>
          <p:grpSpPr>
            <a:xfrm>
              <a:off x="3809482" y="1830843"/>
              <a:ext cx="627863" cy="276999"/>
              <a:chOff x="2363249" y="2419148"/>
              <a:chExt cx="837151" cy="369332"/>
            </a:xfrm>
          </p:grpSpPr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1FEEEB97-EBAF-5123-EC4C-0A70BA31B0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63249" y="2743200"/>
                <a:ext cx="83715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0EE6DB6-A931-D928-02DF-7FC83C25AC74}"/>
                  </a:ext>
                </a:extLst>
              </p:cNvPr>
              <p:cNvSpPr txBox="1"/>
              <p:nvPr/>
            </p:nvSpPr>
            <p:spPr>
              <a:xfrm>
                <a:off x="2411966" y="2419148"/>
                <a:ext cx="7296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40</a:t>
                </a:r>
                <a:r>
                  <a:rPr lang="en-US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m</a:t>
                </a:r>
                <a:endParaRPr lang="en-US" sz="1200" dirty="0"/>
              </a:p>
            </p:txBody>
          </p:sp>
        </p:grpSp>
        <p:grpSp>
          <p:nvGrpSpPr>
            <p:cNvPr id="1025" name="Group 1024">
              <a:extLst>
                <a:ext uri="{FF2B5EF4-FFF2-40B4-BE49-F238E27FC236}">
                  <a16:creationId xmlns:a16="http://schemas.microsoft.com/office/drawing/2014/main" id="{1A008217-245B-44A9-B5BC-9B56E3FAC49F}"/>
                </a:ext>
              </a:extLst>
            </p:cNvPr>
            <p:cNvGrpSpPr/>
            <p:nvPr/>
          </p:nvGrpSpPr>
          <p:grpSpPr>
            <a:xfrm>
              <a:off x="5696737" y="1800775"/>
              <a:ext cx="627863" cy="294735"/>
              <a:chOff x="2363249" y="2350220"/>
              <a:chExt cx="837151" cy="392980"/>
            </a:xfrm>
          </p:grpSpPr>
          <p:cxnSp>
            <p:nvCxnSpPr>
              <p:cNvPr id="1026" name="Straight Connector 1025">
                <a:extLst>
                  <a:ext uri="{FF2B5EF4-FFF2-40B4-BE49-F238E27FC236}">
                    <a16:creationId xmlns:a16="http://schemas.microsoft.com/office/drawing/2014/main" id="{F0F21F63-6038-6C4B-4A3C-618ED7FAEB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63249" y="2743200"/>
                <a:ext cx="83715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9" name="TextBox 1028">
                <a:extLst>
                  <a:ext uri="{FF2B5EF4-FFF2-40B4-BE49-F238E27FC236}">
                    <a16:creationId xmlns:a16="http://schemas.microsoft.com/office/drawing/2014/main" id="{A00A3789-739F-9DF1-7214-AE3068EB3EED}"/>
                  </a:ext>
                </a:extLst>
              </p:cNvPr>
              <p:cNvSpPr txBox="1"/>
              <p:nvPr/>
            </p:nvSpPr>
            <p:spPr>
              <a:xfrm>
                <a:off x="2394794" y="2350220"/>
                <a:ext cx="7296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40</a:t>
                </a:r>
                <a:r>
                  <a:rPr lang="en-US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m</a:t>
                </a:r>
                <a:endParaRPr lang="en-US" sz="1200" dirty="0"/>
              </a:p>
            </p:txBody>
          </p:sp>
        </p:grpSp>
        <p:grpSp>
          <p:nvGrpSpPr>
            <p:cNvPr id="1033" name="Group 1032">
              <a:extLst>
                <a:ext uri="{FF2B5EF4-FFF2-40B4-BE49-F238E27FC236}">
                  <a16:creationId xmlns:a16="http://schemas.microsoft.com/office/drawing/2014/main" id="{B1D02423-B6F2-4C1D-BB29-73A4BA73705C}"/>
                </a:ext>
              </a:extLst>
            </p:cNvPr>
            <p:cNvGrpSpPr/>
            <p:nvPr/>
          </p:nvGrpSpPr>
          <p:grpSpPr>
            <a:xfrm>
              <a:off x="1380977" y="4208134"/>
              <a:ext cx="627863" cy="294735"/>
              <a:chOff x="2363249" y="2350220"/>
              <a:chExt cx="837151" cy="392980"/>
            </a:xfrm>
          </p:grpSpPr>
          <p:cxnSp>
            <p:nvCxnSpPr>
              <p:cNvPr id="1034" name="Straight Connector 1033">
                <a:extLst>
                  <a:ext uri="{FF2B5EF4-FFF2-40B4-BE49-F238E27FC236}">
                    <a16:creationId xmlns:a16="http://schemas.microsoft.com/office/drawing/2014/main" id="{F32EC9DF-6A08-8BB4-1136-C8E85F5407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63249" y="2743200"/>
                <a:ext cx="83715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5" name="TextBox 1034">
                <a:extLst>
                  <a:ext uri="{FF2B5EF4-FFF2-40B4-BE49-F238E27FC236}">
                    <a16:creationId xmlns:a16="http://schemas.microsoft.com/office/drawing/2014/main" id="{B243BD2A-22AF-6C79-910A-5FE5B440AE33}"/>
                  </a:ext>
                </a:extLst>
              </p:cNvPr>
              <p:cNvSpPr txBox="1"/>
              <p:nvPr/>
            </p:nvSpPr>
            <p:spPr>
              <a:xfrm>
                <a:off x="2394794" y="2350220"/>
                <a:ext cx="7296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40</a:t>
                </a:r>
                <a:r>
                  <a:rPr lang="en-US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m</a:t>
                </a:r>
                <a:endParaRPr lang="en-US" sz="1200" dirty="0"/>
              </a:p>
            </p:txBody>
          </p:sp>
        </p:grpSp>
        <p:grpSp>
          <p:nvGrpSpPr>
            <p:cNvPr id="1036" name="Group 1035">
              <a:extLst>
                <a:ext uri="{FF2B5EF4-FFF2-40B4-BE49-F238E27FC236}">
                  <a16:creationId xmlns:a16="http://schemas.microsoft.com/office/drawing/2014/main" id="{49908771-F9E9-4E5C-C3CA-E7B444FB381D}"/>
                </a:ext>
              </a:extLst>
            </p:cNvPr>
            <p:cNvGrpSpPr/>
            <p:nvPr/>
          </p:nvGrpSpPr>
          <p:grpSpPr>
            <a:xfrm>
              <a:off x="3777529" y="3806428"/>
              <a:ext cx="627863" cy="299552"/>
              <a:chOff x="2842695" y="2285903"/>
              <a:chExt cx="837151" cy="399402"/>
            </a:xfrm>
          </p:grpSpPr>
          <p:cxnSp>
            <p:nvCxnSpPr>
              <p:cNvPr id="1037" name="Straight Connector 1036">
                <a:extLst>
                  <a:ext uri="{FF2B5EF4-FFF2-40B4-BE49-F238E27FC236}">
                    <a16:creationId xmlns:a16="http://schemas.microsoft.com/office/drawing/2014/main" id="{E0156194-C1CE-9CD3-7AC2-373AF4D806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42695" y="2685305"/>
                <a:ext cx="83715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8" name="TextBox 1037">
                <a:extLst>
                  <a:ext uri="{FF2B5EF4-FFF2-40B4-BE49-F238E27FC236}">
                    <a16:creationId xmlns:a16="http://schemas.microsoft.com/office/drawing/2014/main" id="{B583EED1-A676-610E-3518-EC7546B06E9D}"/>
                  </a:ext>
                </a:extLst>
              </p:cNvPr>
              <p:cNvSpPr txBox="1"/>
              <p:nvPr/>
            </p:nvSpPr>
            <p:spPr>
              <a:xfrm>
                <a:off x="2842695" y="2285903"/>
                <a:ext cx="7296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40</a:t>
                </a:r>
                <a:r>
                  <a:rPr lang="en-US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m</a:t>
                </a:r>
                <a:endParaRPr lang="en-US" sz="1200" dirty="0"/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97858DFE-B9CA-B797-6B7C-6ADC1B96D10F}"/>
                </a:ext>
              </a:extLst>
            </p:cNvPr>
            <p:cNvGrpSpPr/>
            <p:nvPr/>
          </p:nvGrpSpPr>
          <p:grpSpPr>
            <a:xfrm>
              <a:off x="409565" y="2743973"/>
              <a:ext cx="6105216" cy="4249437"/>
              <a:chOff x="494935" y="302274"/>
              <a:chExt cx="6105216" cy="4249437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73D80006-63F2-4BD4-19AC-9D5CD8B4F4D8}"/>
                  </a:ext>
                </a:extLst>
              </p:cNvPr>
              <p:cNvGrpSpPr/>
              <p:nvPr/>
            </p:nvGrpSpPr>
            <p:grpSpPr>
              <a:xfrm>
                <a:off x="494935" y="302274"/>
                <a:ext cx="6105216" cy="4249437"/>
                <a:chOff x="659913" y="-2771968"/>
                <a:chExt cx="8140288" cy="5665915"/>
              </a:xfrm>
            </p:grpSpPr>
            <p:pic>
              <p:nvPicPr>
                <p:cNvPr id="44" name="Picture 2" descr="D:\Projects &amp; Application\UVS 50 lakhs project, 2020-2021\Eggs and Oocyst photos\Hyostrongylus\Hyostrongylus X40.jpg">
                  <a:extLst>
                    <a:ext uri="{FF2B5EF4-FFF2-40B4-BE49-F238E27FC236}">
                      <a16:creationId xmlns:a16="http://schemas.microsoft.com/office/drawing/2014/main" id="{CA6C4DE2-A50E-F976-691A-AE6F64B4908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353" t="44522" r="52647" b="35652"/>
                <a:stretch/>
              </p:blipFill>
              <p:spPr bwMode="auto">
                <a:xfrm rot="16200000">
                  <a:off x="6739187" y="-2493121"/>
                  <a:ext cx="2187886" cy="163019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" name="Picture 3" descr="D:\Projects &amp; Application\UVS 50 lakhs project, 2020-2021\Eggs and Oocyst photos\Fasciolopsis\Fasciolipsis X40 (2).jpg">
                  <a:extLst>
                    <a:ext uri="{FF2B5EF4-FFF2-40B4-BE49-F238E27FC236}">
                      <a16:creationId xmlns:a16="http://schemas.microsoft.com/office/drawing/2014/main" id="{12D7ACEE-8955-3662-CC91-A4C60C1F88F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031" t="37904" r="46175" b="35653"/>
                <a:stretch/>
              </p:blipFill>
              <p:spPr bwMode="auto">
                <a:xfrm>
                  <a:off x="659913" y="433827"/>
                  <a:ext cx="2478496" cy="207637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6" name="Picture 4" descr="D:\Projects &amp; Application\UVS 50 lakhs project, 2020-2021\Eggs and Oocyst photos\Paragonimus\Paragonimus X10.jpg">
                  <a:extLst>
                    <a:ext uri="{FF2B5EF4-FFF2-40B4-BE49-F238E27FC236}">
                      <a16:creationId xmlns:a16="http://schemas.microsoft.com/office/drawing/2014/main" id="{D8F1F444-524A-51F5-0922-298914BF96D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6" cstate="print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226" t="55443" r="56989" b="31250"/>
                <a:stretch/>
              </p:blipFill>
              <p:spPr bwMode="auto">
                <a:xfrm>
                  <a:off x="4111477" y="526021"/>
                  <a:ext cx="1716489" cy="205978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7" name="Picture 5" descr="D:\Projects &amp; Application\UVS 50 lakhs project, 2020-2021\Eggs and Oocyst photos\Schistosome eggs\IMG_20200312_145103.jpg">
                  <a:extLst>
                    <a:ext uri="{FF2B5EF4-FFF2-40B4-BE49-F238E27FC236}">
                      <a16:creationId xmlns:a16="http://schemas.microsoft.com/office/drawing/2014/main" id="{CC50080E-92C1-8D96-8E0A-4F1A369C552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8" cstate="print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528" t="44556" r="64705" b="30566"/>
                <a:stretch/>
              </p:blipFill>
              <p:spPr bwMode="auto">
                <a:xfrm>
                  <a:off x="6681841" y="368662"/>
                  <a:ext cx="2118360" cy="252528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70093447-67C4-6A9A-FEC7-56651A5107C2}"/>
                  </a:ext>
                </a:extLst>
              </p:cNvPr>
              <p:cNvGrpSpPr/>
              <p:nvPr/>
            </p:nvGrpSpPr>
            <p:grpSpPr>
              <a:xfrm>
                <a:off x="5556448" y="1553904"/>
                <a:ext cx="627863" cy="294735"/>
                <a:chOff x="8444118" y="-759327"/>
                <a:chExt cx="837151" cy="392980"/>
              </a:xfrm>
            </p:grpSpPr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id="{4568B92C-AEAE-D095-D989-126D07B2C1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44118" y="-366347"/>
                  <a:ext cx="83715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A38F6437-18B7-6E50-64FD-04275DD75E67}"/>
                    </a:ext>
                  </a:extLst>
                </p:cNvPr>
                <p:cNvSpPr txBox="1"/>
                <p:nvPr/>
              </p:nvSpPr>
              <p:spPr>
                <a:xfrm>
                  <a:off x="8475663" y="-759327"/>
                  <a:ext cx="72968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40</a:t>
                  </a:r>
                  <a:r>
                    <a:rPr lang="en-US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µm</a:t>
                  </a:r>
                  <a:endParaRPr lang="en-US" sz="1200" dirty="0"/>
                </a:p>
              </p:txBody>
            </p:sp>
          </p:grp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AFCB4878-0088-EB6E-BFA9-666464BE5349}"/>
                  </a:ext>
                </a:extLst>
              </p:cNvPr>
              <p:cNvGrpSpPr/>
              <p:nvPr/>
            </p:nvGrpSpPr>
            <p:grpSpPr>
              <a:xfrm>
                <a:off x="1677742" y="3860109"/>
                <a:ext cx="707004" cy="276999"/>
                <a:chOff x="-365546" y="2264788"/>
                <a:chExt cx="942672" cy="369332"/>
              </a:xfrm>
            </p:grpSpPr>
            <p:cxnSp>
              <p:nvCxnSpPr>
                <p:cNvPr id="40" name="Straight Connector 39">
                  <a:extLst>
                    <a:ext uri="{FF2B5EF4-FFF2-40B4-BE49-F238E27FC236}">
                      <a16:creationId xmlns:a16="http://schemas.microsoft.com/office/drawing/2014/main" id="{D1C47341-6033-72CD-F6AC-C1747150F6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365546" y="2634120"/>
                  <a:ext cx="83715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FD0D9F4B-2BC8-1773-5030-7D9D56F46C4B}"/>
                    </a:ext>
                  </a:extLst>
                </p:cNvPr>
                <p:cNvSpPr txBox="1"/>
                <p:nvPr/>
              </p:nvSpPr>
              <p:spPr>
                <a:xfrm>
                  <a:off x="-152561" y="2264788"/>
                  <a:ext cx="72968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40</a:t>
                  </a:r>
                  <a:r>
                    <a:rPr lang="en-US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µm</a:t>
                  </a:r>
                  <a:endParaRPr lang="en-US" sz="1200" dirty="0"/>
                </a:p>
              </p:txBody>
            </p:sp>
          </p:grp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E1A43065-A4CD-A0AC-54C6-30806720AE50}"/>
                  </a:ext>
                </a:extLst>
              </p:cNvPr>
              <p:cNvGrpSpPr/>
              <p:nvPr/>
            </p:nvGrpSpPr>
            <p:grpSpPr>
              <a:xfrm>
                <a:off x="3803899" y="3890948"/>
                <a:ext cx="643137" cy="276999"/>
                <a:chOff x="-184890" y="2340252"/>
                <a:chExt cx="857514" cy="369332"/>
              </a:xfrm>
            </p:grpSpPr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id="{8364856D-0CE6-8AF6-885B-550C0E0F989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64529" y="2650063"/>
                  <a:ext cx="83715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C89C6D80-323A-61C3-1590-64FD1411BAE7}"/>
                    </a:ext>
                  </a:extLst>
                </p:cNvPr>
                <p:cNvSpPr txBox="1"/>
                <p:nvPr/>
              </p:nvSpPr>
              <p:spPr>
                <a:xfrm>
                  <a:off x="-184890" y="2340252"/>
                  <a:ext cx="72968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40</a:t>
                  </a:r>
                  <a:r>
                    <a:rPr lang="en-US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µm</a:t>
                  </a:r>
                  <a:endParaRPr lang="en-US" sz="1200" dirty="0"/>
                </a:p>
              </p:txBody>
            </p:sp>
          </p:grp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E9021A3C-FB0D-EED1-F325-2E2C22F6305B}"/>
                  </a:ext>
                </a:extLst>
              </p:cNvPr>
              <p:cNvGrpSpPr/>
              <p:nvPr/>
            </p:nvGrpSpPr>
            <p:grpSpPr>
              <a:xfrm>
                <a:off x="5902369" y="4079725"/>
                <a:ext cx="627863" cy="276999"/>
                <a:chOff x="8136523" y="-1057385"/>
                <a:chExt cx="837151" cy="369332"/>
              </a:xfrm>
            </p:grpSpPr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12BC9F38-8048-7FFF-C98F-0E9CC78808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36523" y="-763054"/>
                  <a:ext cx="83715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87D789FE-D43D-5EB6-CC8D-AEC5196EB36A}"/>
                    </a:ext>
                  </a:extLst>
                </p:cNvPr>
                <p:cNvSpPr txBox="1"/>
                <p:nvPr/>
              </p:nvSpPr>
              <p:spPr>
                <a:xfrm>
                  <a:off x="8243987" y="-1057385"/>
                  <a:ext cx="72968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40</a:t>
                  </a:r>
                  <a:r>
                    <a:rPr lang="en-US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µm</a:t>
                  </a:r>
                  <a:endParaRPr lang="en-US" sz="1200" dirty="0"/>
                </a:p>
              </p:txBody>
            </p:sp>
          </p:grpSp>
        </p:grp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19228E3A-0F82-1402-4F1F-48A44012E9B7}"/>
              </a:ext>
            </a:extLst>
          </p:cNvPr>
          <p:cNvSpPr txBox="1"/>
          <p:nvPr/>
        </p:nvSpPr>
        <p:spPr>
          <a:xfrm>
            <a:off x="20276" y="23611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42FD331-D7AF-2EFC-C2F4-BE16FA94D5EE}"/>
              </a:ext>
            </a:extLst>
          </p:cNvPr>
          <p:cNvSpPr txBox="1"/>
          <p:nvPr/>
        </p:nvSpPr>
        <p:spPr>
          <a:xfrm>
            <a:off x="2372413" y="202836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98D3E26-B560-07EA-7C4A-225319D120DE}"/>
              </a:ext>
            </a:extLst>
          </p:cNvPr>
          <p:cNvSpPr txBox="1"/>
          <p:nvPr/>
        </p:nvSpPr>
        <p:spPr>
          <a:xfrm>
            <a:off x="4447310" y="22860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9751C8-2E13-86F6-5CEE-AB81EE64018D}"/>
              </a:ext>
            </a:extLst>
          </p:cNvPr>
          <p:cNvSpPr txBox="1"/>
          <p:nvPr/>
        </p:nvSpPr>
        <p:spPr>
          <a:xfrm>
            <a:off x="27710" y="267787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C9E30DD-D6AB-96D2-885A-22D95A27E22F}"/>
              </a:ext>
            </a:extLst>
          </p:cNvPr>
          <p:cNvSpPr txBox="1"/>
          <p:nvPr/>
        </p:nvSpPr>
        <p:spPr>
          <a:xfrm>
            <a:off x="2286000" y="2664023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6BBF17-2762-F8BC-2BDB-C26EB5A15B88}"/>
              </a:ext>
            </a:extLst>
          </p:cNvPr>
          <p:cNvSpPr txBox="1"/>
          <p:nvPr/>
        </p:nvSpPr>
        <p:spPr>
          <a:xfrm>
            <a:off x="4672268" y="2664023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1043292-C23A-02A7-A2EA-1210D3BE2E10}"/>
              </a:ext>
            </a:extLst>
          </p:cNvPr>
          <p:cNvSpPr txBox="1"/>
          <p:nvPr/>
        </p:nvSpPr>
        <p:spPr>
          <a:xfrm>
            <a:off x="61836" y="510242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D7554E-35B3-103F-F9D6-FE30769F883A}"/>
              </a:ext>
            </a:extLst>
          </p:cNvPr>
          <p:cNvSpPr txBox="1"/>
          <p:nvPr/>
        </p:nvSpPr>
        <p:spPr>
          <a:xfrm>
            <a:off x="2579361" y="506357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E496CB8-228C-7B1F-15A5-2732D0650B77}"/>
              </a:ext>
            </a:extLst>
          </p:cNvPr>
          <p:cNvSpPr txBox="1"/>
          <p:nvPr/>
        </p:nvSpPr>
        <p:spPr>
          <a:xfrm>
            <a:off x="4531317" y="5074829"/>
            <a:ext cx="3626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D41EA3-DA5D-07BA-E787-73C98515DD81}"/>
              </a:ext>
            </a:extLst>
          </p:cNvPr>
          <p:cNvSpPr txBox="1"/>
          <p:nvPr/>
        </p:nvSpPr>
        <p:spPr>
          <a:xfrm>
            <a:off x="152400" y="7497274"/>
            <a:ext cx="6553200" cy="8937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(A-I). 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ggs of </a:t>
            </a:r>
            <a:r>
              <a:rPr lang="en-GB" sz="1200" i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caris </a:t>
            </a:r>
            <a:r>
              <a:rPr lang="en-GB" sz="1200" i="1" dirty="0" err="1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um</a:t>
            </a:r>
            <a:r>
              <a:rPr lang="en-GB" sz="1200" i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, </a:t>
            </a:r>
            <a:r>
              <a:rPr lang="en-GB" sz="1200" i="1" dirty="0" err="1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esophagostomum</a:t>
            </a:r>
            <a:r>
              <a:rPr lang="en-GB" sz="1200" i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p. (B), </a:t>
            </a:r>
            <a:r>
              <a:rPr lang="en-GB" sz="1200" i="1" dirty="0" err="1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ongyloides</a:t>
            </a:r>
            <a:r>
              <a:rPr lang="en-GB" sz="1200" i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p. (C), </a:t>
            </a:r>
            <a:r>
              <a:rPr lang="en-GB" sz="1200" i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ichuris suis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), </a:t>
            </a:r>
            <a:r>
              <a:rPr lang="en-GB" sz="1200" i="1" dirty="0" err="1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astrongylus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p. (E), </a:t>
            </a:r>
            <a:r>
              <a:rPr lang="en-GB" sz="1200" i="1" dirty="0" err="1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ostrongylus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p. (F), </a:t>
            </a:r>
            <a:r>
              <a:rPr lang="en-GB" sz="1200" i="1" dirty="0" err="1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sciolopsis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p. (G), </a:t>
            </a:r>
            <a:r>
              <a:rPr lang="en-GB" sz="1200" i="1" dirty="0" err="1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ragonimus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p. (H), and </a:t>
            </a:r>
            <a:r>
              <a:rPr lang="en-GB" sz="1200" i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istosoma</a:t>
            </a:r>
            <a:r>
              <a:rPr lang="en-GB" sz="12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p. (I) detected in this study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4038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5</TotalTime>
  <Words>102</Words>
  <Application>Microsoft Office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orphological and Molecular Identification of Gastrointestinal Parasites of Pigs within Nay Pyi Taw Area</dc:title>
  <dc:creator>hpuser</dc:creator>
  <cp:lastModifiedBy>sawvet</cp:lastModifiedBy>
  <cp:revision>141</cp:revision>
  <dcterms:created xsi:type="dcterms:W3CDTF">2022-10-27T03:50:48Z</dcterms:created>
  <dcterms:modified xsi:type="dcterms:W3CDTF">2024-02-15T14:42:58Z</dcterms:modified>
</cp:coreProperties>
</file>